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76B701-D61D-4366-BF42-BA36CA00777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C3D8E6-7E3C-46D1-8FEB-93FD35219C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34855B-1A03-448C-A69D-08BE8FEFFD8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3ADA43-83A2-4257-B5A2-398FD313D14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0F5EB0-CDAC-42B4-9832-BC5D3A8F16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DC5869-A018-4AFA-96B3-B595457A22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B9F828-865C-45BA-BDDD-A9457F9AEB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8B865F-DE57-4B3B-928C-170D429A90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5A44B0-740E-4D99-924B-3B2DB40F87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E8C5EF-16FB-43AC-B908-5386F077F4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D7703C-2A03-49D5-8AE9-C4C7A73C52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272350-6E12-4673-BB93-F6A4D1D8BB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F5E6583-6081-4EB7-9097-4627B344D7A3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hteck 15"/>
          <p:cNvSpPr/>
          <p:nvPr/>
        </p:nvSpPr>
        <p:spPr>
          <a:xfrm>
            <a:off x="13680" y="-90360"/>
            <a:ext cx="27853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Rectangle 25"/>
          <p:cNvSpPr/>
          <p:nvPr/>
        </p:nvSpPr>
        <p:spPr>
          <a:xfrm>
            <a:off x="0" y="646200"/>
            <a:ext cx="91440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3" name="Gruppierung 25"/>
          <p:cNvGrpSpPr/>
          <p:nvPr/>
        </p:nvGrpSpPr>
        <p:grpSpPr>
          <a:xfrm>
            <a:off x="0" y="469800"/>
            <a:ext cx="4584600" cy="3181320"/>
            <a:chOff x="0" y="469800"/>
            <a:chExt cx="4584600" cy="3181320"/>
          </a:xfrm>
        </p:grpSpPr>
        <p:pic>
          <p:nvPicPr>
            <p:cNvPr id="44" name="Bild 26" descr=""/>
            <p:cNvPicPr/>
            <p:nvPr/>
          </p:nvPicPr>
          <p:blipFill>
            <a:blip r:embed="rId1"/>
            <a:stretch/>
          </p:blipFill>
          <p:spPr>
            <a:xfrm>
              <a:off x="0" y="866520"/>
              <a:ext cx="4584600" cy="2784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Textfeld 27"/>
            <p:cNvSpPr/>
            <p:nvPr/>
          </p:nvSpPr>
          <p:spPr>
            <a:xfrm>
              <a:off x="732960" y="469800"/>
              <a:ext cx="337212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Isolated mitochondria - State III Respiration</a:t>
              </a: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Octanoyl-carnitine + Glutamate + Succinat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6" name="Rectangle 27"/>
          <p:cNvSpPr/>
          <p:nvPr/>
        </p:nvSpPr>
        <p:spPr>
          <a:xfrm>
            <a:off x="0" y="428472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Rechteck 1"/>
          <p:cNvSpPr/>
          <p:nvPr/>
        </p:nvSpPr>
        <p:spPr>
          <a:xfrm>
            <a:off x="0" y="3651120"/>
            <a:ext cx="4572000" cy="139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State III mitochondrial respiration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on octanoyl-carnitine and the citrate cycle derived substrates glutamate and succinate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in isolated mitochondria from left ventricular apex tissue specimens obtained during LVAD surgery in BIOPS or CUSTODIOL</a:t>
            </a:r>
            <a:r>
              <a:rPr b="0" lang="de-DE" sz="12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®</a:t>
            </a:r>
            <a:r>
              <a:rPr b="0" lang="de-DE" sz="1200" spc="-1" strike="noStrike" baseline="-25000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preservation buffer. Isolation of mitochondria was started within 30 minutes after tissue accqusition. Student´s t-Test. Data are means ± SEM (n=8/group).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3-22T23:12:38Z</dcterms:created>
  <dc:creator>Daniel Scheiber</dc:creator>
  <dc:description/>
  <dc:language>en-US</dc:language>
  <cp:lastModifiedBy>Daniel Scheiber</cp:lastModifiedBy>
  <dcterms:modified xsi:type="dcterms:W3CDTF">2018-03-29T22:48:07Z</dcterms:modified>
  <cp:revision>9</cp:revision>
  <dc:subject/>
  <dc:title>PowerPoint-Präsentation</dc:title>
</cp:coreProperties>
</file>